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73" userDrawn="1">
          <p15:clr>
            <a:srgbClr val="A4A3A4"/>
          </p15:clr>
        </p15:guide>
        <p15:guide id="2" pos="708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147" d="100"/>
          <a:sy n="147" d="100"/>
        </p:scale>
        <p:origin x="696" y="114"/>
      </p:cViewPr>
      <p:guideLst>
        <p:guide orient="horz" pos="73"/>
        <p:guide pos="708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655766D-AC05-369A-7923-24255EA47FC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CDBAE3DB-DFEF-0DD4-100F-BE058D2BB4E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A4782AE-854B-2845-569B-76A4E4699E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2F01F-F5CA-4347-8D7D-46C67DDB8C01}" type="datetimeFigureOut">
              <a:rPr lang="de-DE" smtClean="0"/>
              <a:t>23.02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E4927C0-B163-CEB7-1E4D-07CE24E04E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988C0A1-A4F0-2B9F-A706-1A4B56AA07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36CB9-966B-479E-9247-3EBC911B1B8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552906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94B0BD3-E414-F3EE-B433-BA1D02469D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458F9130-37EC-D354-ABAA-4F65760FF2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ADCA318-E126-28E6-B71B-A68EFD316A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2F01F-F5CA-4347-8D7D-46C67DDB8C01}" type="datetimeFigureOut">
              <a:rPr lang="de-DE" smtClean="0"/>
              <a:t>23.02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2AE4C9E-282C-8AB9-4821-4FF2EBE36E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A71B607-2E1C-E20B-9A80-957FF5706E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36CB9-966B-479E-9247-3EBC911B1B8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250516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62626DB8-83E7-1FF0-5F6D-720A88D2C24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0A978952-F6BA-36C5-3AE8-ED7A0328E4C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07210F9-3CD4-45DD-B9B0-8D4666A587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2F01F-F5CA-4347-8D7D-46C67DDB8C01}" type="datetimeFigureOut">
              <a:rPr lang="de-DE" smtClean="0"/>
              <a:t>23.02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D373060-AB25-A7B7-3CE8-4B69C4EA2D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A1C73CC-4C73-FD61-7480-9DF0AAA539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36CB9-966B-479E-9247-3EBC911B1B8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320264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14A4183-E4BB-97A4-0F9F-F7D3F8C77D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05361374-9647-6D67-B2E2-6FB9FB00510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6D5D9FA-556C-BCE0-3A19-5E1FDFD394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2F01F-F5CA-4347-8D7D-46C67DDB8C01}" type="datetimeFigureOut">
              <a:rPr lang="de-DE" smtClean="0"/>
              <a:t>23.02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4DAAEDA8-5D66-7C58-03A5-63704CA85C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3BCE380-2FCF-6F98-E86A-C8F6EAE677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36CB9-966B-479E-9247-3EBC911B1B8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679575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FEA7C1D-A83D-9FDE-C320-02C099157A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00C80E1F-C47E-CABA-F55C-CA5E3B1175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C399AA3-3BB6-4CEB-4CC5-D0D003AAE9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2F01F-F5CA-4347-8D7D-46C67DDB8C01}" type="datetimeFigureOut">
              <a:rPr lang="de-DE" smtClean="0"/>
              <a:t>23.02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829A6A1-1269-A4D3-56BE-C80711BB4A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BF62265-09DE-5429-D984-3BF8725075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36CB9-966B-479E-9247-3EBC911B1B8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068765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C0A7F13-0A00-1939-ABE5-11693A0CD3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30ABFE60-DAD2-4C59-07EC-2842416BAB9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15D12C0D-FE8B-671C-8873-BD43C212606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D64951FD-85B3-3927-C58D-61A727A7C9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2F01F-F5CA-4347-8D7D-46C67DDB8C01}" type="datetimeFigureOut">
              <a:rPr lang="de-DE" smtClean="0"/>
              <a:t>23.02.20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41EDDAC9-A5DA-FA63-22CA-1C9FA4F136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D7C11D54-C5EA-ACDB-B137-FDBF6A678F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36CB9-966B-479E-9247-3EBC911B1B8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075834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8A850E1-A45E-6A41-A965-DAF7A29341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3D1C7941-B327-94A1-0026-1A66D34380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0BFBEB92-33CF-733C-EBD5-CB696F8C062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C69A1459-ECE1-FD41-60C0-17283193B6E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DE5C21C1-E3A1-BD87-B58B-14EBF9F7201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F64BAAD9-8487-0FC7-6F7C-CFB0455CD5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2F01F-F5CA-4347-8D7D-46C67DDB8C01}" type="datetimeFigureOut">
              <a:rPr lang="de-DE" smtClean="0"/>
              <a:t>23.02.2026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75271DC9-7EB9-ED65-CC3C-E380D39615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43B88ECB-D82C-93D8-AFAB-247F407A45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36CB9-966B-479E-9247-3EBC911B1B8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402391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65F22D7-7117-4EEF-3ED3-52E3ADB564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F6D9D2AC-9D02-6A59-0685-6764BABBEE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2F01F-F5CA-4347-8D7D-46C67DDB8C01}" type="datetimeFigureOut">
              <a:rPr lang="de-DE" smtClean="0"/>
              <a:t>23.02.2026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CB53AFB1-57EB-E807-CE53-1D3DB95F06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593A8313-3759-B7F7-47CC-F6632644D7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36CB9-966B-479E-9247-3EBC911B1B8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352811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610561F8-326F-707E-76CA-E7A365E07A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2F01F-F5CA-4347-8D7D-46C67DDB8C01}" type="datetimeFigureOut">
              <a:rPr lang="de-DE" smtClean="0"/>
              <a:t>23.02.2026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26BF2C64-D4F7-2629-4110-1FAA4449B9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89E5AF64-413A-42B9-8C9D-B1B2AC7D13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36CB9-966B-479E-9247-3EBC911B1B8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819343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9367075-FD45-DC1A-60FC-723A446A17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359A2F6A-1534-D594-4496-9B37DDC97C3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D8388282-A177-0E89-1362-88B8079C884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CD1E680E-8A0E-CCA2-25AB-439E14C60D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2F01F-F5CA-4347-8D7D-46C67DDB8C01}" type="datetimeFigureOut">
              <a:rPr lang="de-DE" smtClean="0"/>
              <a:t>23.02.20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6DA94884-C845-4F03-C165-E5E048A494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386B93F9-F143-20D0-4E0E-A2EA9AF13F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36CB9-966B-479E-9247-3EBC911B1B8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327379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D9D12C5-559F-CB20-270D-DB13DF6AFA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B1CC91D2-6E8E-602A-B57A-DD28DF3EF87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24E62E6C-9917-F808-C7E0-C53C5867BEE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B6A95851-164F-68AF-DEF0-60C3769AE8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2F01F-F5CA-4347-8D7D-46C67DDB8C01}" type="datetimeFigureOut">
              <a:rPr lang="de-DE" smtClean="0"/>
              <a:t>23.02.20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CAF87E46-EA61-A5ED-6D2D-4788675B22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C84DFB55-E608-5C58-59AE-A250A2B59A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36CB9-966B-479E-9247-3EBC911B1B8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482948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7D763D3B-1345-290B-1590-CB118BCA51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E1F8632F-71BC-5312-788B-FD57028E0F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C2B73D4-16AF-9806-45BA-98ED0E5BED1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332F01F-F5CA-4347-8D7D-46C67DDB8C01}" type="datetimeFigureOut">
              <a:rPr lang="de-DE" smtClean="0"/>
              <a:t>23.02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83341F49-42E9-87BC-82F6-57AC85D28F9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7D60CC82-0AF2-5813-67DC-DCC1E8A7E55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C836CB9-966B-479E-9247-3EBC911B1B8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329529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 descr="Ein Bild, das Dunkelheit, Screenshot, Reihe, Licht enthält.&#10;&#10;KI-generierte Inhalte können fehlerhaft sein.">
            <a:extLst>
              <a:ext uri="{FF2B5EF4-FFF2-40B4-BE49-F238E27FC236}">
                <a16:creationId xmlns:a16="http://schemas.microsoft.com/office/drawing/2014/main" id="{76ED186B-FF03-83E6-E22C-E6B3A16EA5A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06991" y="361518"/>
            <a:ext cx="4378018" cy="3067482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F8598F0E-5A77-CFDB-4303-E3C0DE13EDD8}"/>
              </a:ext>
            </a:extLst>
          </p:cNvPr>
          <p:cNvSpPr txBox="1"/>
          <p:nvPr/>
        </p:nvSpPr>
        <p:spPr>
          <a:xfrm>
            <a:off x="3906991" y="3429000"/>
            <a:ext cx="4378018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noProof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sCD83 does not enhance wound closure in the absence of macrophages. </a:t>
            </a:r>
            <a:r>
              <a:rPr lang="en-US" sz="1200" noProof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assess whether the pro-regenerative effects of sCD83 are macrophage-dependent, 3D skin constructs were generated without macrophages. Constructs were wounded and treated with either PBS or 25 µg/mL sCD83 under identical culture conditions. No significant (ns) differences in normalized wound closure were observed between sCD83-treated and PBS-treated constructs at the indicated time points (n=4  per group). Data are presented as mean ± SEM. Statistical analysis was performed using an unpaired t-test.</a:t>
            </a:r>
          </a:p>
        </p:txBody>
      </p:sp>
    </p:spTree>
    <p:extLst>
      <p:ext uri="{BB962C8B-B14F-4D97-AF65-F5344CB8AC3E}">
        <p14:creationId xmlns:p14="http://schemas.microsoft.com/office/powerpoint/2010/main" val="28156551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0</Words>
  <Application>Microsoft Office PowerPoint</Application>
  <PresentationFormat>Breitbild</PresentationFormat>
  <Paragraphs>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ollard, Christian</dc:creator>
  <cp:lastModifiedBy>Hollard, Christian</cp:lastModifiedBy>
  <cp:revision>3</cp:revision>
  <dcterms:created xsi:type="dcterms:W3CDTF">2026-02-14T13:09:34Z</dcterms:created>
  <dcterms:modified xsi:type="dcterms:W3CDTF">2026-02-23T19:29:18Z</dcterms:modified>
</cp:coreProperties>
</file>